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70" d="100"/>
          <a:sy n="70" d="100"/>
        </p:scale>
        <p:origin x="-2712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2B413-2CB6-D440-9EB2-981114B60195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B395C-A427-7149-8D6A-B403FF5AA0D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939340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2B413-2CB6-D440-9EB2-981114B60195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B395C-A427-7149-8D6A-B403FF5AA0D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65146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2B413-2CB6-D440-9EB2-981114B60195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B395C-A427-7149-8D6A-B403FF5AA0D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39612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2B413-2CB6-D440-9EB2-981114B60195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B395C-A427-7149-8D6A-B403FF5AA0D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041249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2B413-2CB6-D440-9EB2-981114B60195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B395C-A427-7149-8D6A-B403FF5AA0D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851508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2B413-2CB6-D440-9EB2-981114B60195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B395C-A427-7149-8D6A-B403FF5AA0D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856018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2B413-2CB6-D440-9EB2-981114B60195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B395C-A427-7149-8D6A-B403FF5AA0D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41143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2B413-2CB6-D440-9EB2-981114B60195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B395C-A427-7149-8D6A-B403FF5AA0D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353224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2B413-2CB6-D440-9EB2-981114B60195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B395C-A427-7149-8D6A-B403FF5AA0D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812316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2B413-2CB6-D440-9EB2-981114B60195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B395C-A427-7149-8D6A-B403FF5AA0D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003191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2B413-2CB6-D440-9EB2-981114B60195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B395C-A427-7149-8D6A-B403FF5AA0D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323428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52B413-2CB6-D440-9EB2-981114B60195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2B395C-A427-7149-8D6A-B403FF5AA0D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037150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95668273"/>
              </p:ext>
            </p:extLst>
          </p:nvPr>
        </p:nvGraphicFramePr>
        <p:xfrm>
          <a:off x="1352550" y="2365846"/>
          <a:ext cx="6438900" cy="1850553"/>
        </p:xfrm>
        <a:graphic>
          <a:graphicData uri="http://schemas.openxmlformats.org/drawingml/2006/table">
            <a:tbl>
              <a:tblPr/>
              <a:tblGrid>
                <a:gridCol w="3022600"/>
                <a:gridCol w="869950"/>
                <a:gridCol w="857250"/>
                <a:gridCol w="825500"/>
                <a:gridCol w="863600"/>
              </a:tblGrid>
              <a:tr h="205617">
                <a:tc gridSpan="2">
                  <a:txBody>
                    <a:bodyPr/>
                    <a:lstStyle/>
                    <a:p>
                      <a:pPr algn="l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0561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ndividual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S9_1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S9_2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S9_3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S9_4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05617">
                <a:tc>
                  <a:txBody>
                    <a:bodyPr/>
                    <a:lstStyle/>
                    <a:p>
                      <a:pPr algn="l" fontAlgn="b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zh-CN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zh-CN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0561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otal Reads (number)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7551802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4121168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9928482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5409580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0561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ase covered on target (number)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0332600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0329502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0280146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0327888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0561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otal effective yield (Mb)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578.37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195.84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842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226.21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0561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overage of target region (%)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9.90%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9.90%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9.80%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9.90%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0561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verage sequencing depth on target (X)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0.86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3.27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6.24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3.87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0561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raction of target covered ≥20X (%)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6.70%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5.90%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5.00%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6.00%</a:t>
                      </a:r>
                    </a:p>
                  </a:txBody>
                  <a:tcPr marL="12700" marR="12700" marT="12700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5182122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9</Words>
  <Application>Microsoft Macintosh PowerPoint</Application>
  <PresentationFormat>全屏显示(4:3)</PresentationFormat>
  <Paragraphs>40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Company>中南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ong Ma</dc:creator>
  <cp:lastModifiedBy>Long Ma</cp:lastModifiedBy>
  <cp:revision>2</cp:revision>
  <cp:lastPrinted>2018-06-04T06:58:14Z</cp:lastPrinted>
  <dcterms:created xsi:type="dcterms:W3CDTF">2018-06-04T06:24:21Z</dcterms:created>
  <dcterms:modified xsi:type="dcterms:W3CDTF">2018-06-04T06:58:21Z</dcterms:modified>
</cp:coreProperties>
</file>